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0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0000CC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74" autoAdjust="0"/>
  </p:normalViewPr>
  <p:slideViewPr>
    <p:cSldViewPr snapToObjects="1">
      <p:cViewPr varScale="1">
        <p:scale>
          <a:sx n="86" d="100"/>
          <a:sy n="86" d="100"/>
        </p:scale>
        <p:origin x="1339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13/02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13/02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B0FBD28-74D8-4AD6-931F-BA8448CF32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9839" y="580073"/>
            <a:ext cx="3659133" cy="2848927"/>
          </a:xfrm>
          <a:prstGeom prst="rect">
            <a:avLst/>
          </a:prstGeom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58AE90D-54DD-402B-BFCF-10EA0E163BEB}"/>
              </a:ext>
            </a:extLst>
          </p:cNvPr>
          <p:cNvSpPr txBox="1"/>
          <p:nvPr/>
        </p:nvSpPr>
        <p:spPr>
          <a:xfrm>
            <a:off x="-11135" y="44624"/>
            <a:ext cx="9144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gure S1. Additional Western blots showing different CRISPR clones generated from each construct. </a:t>
            </a:r>
          </a:p>
          <a:p>
            <a:pPr algn="ctr"/>
            <a:r>
              <a: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Refers to Figure 1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6DECDD1-E496-4CFF-B174-3D05F2A0918D}"/>
              </a:ext>
            </a:extLst>
          </p:cNvPr>
          <p:cNvSpPr txBox="1"/>
          <p:nvPr/>
        </p:nvSpPr>
        <p:spPr>
          <a:xfrm>
            <a:off x="251520" y="54868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367A34A-69C5-4F2C-A1CE-8CCE50EC6E90}"/>
              </a:ext>
            </a:extLst>
          </p:cNvPr>
          <p:cNvSpPr txBox="1"/>
          <p:nvPr/>
        </p:nvSpPr>
        <p:spPr>
          <a:xfrm>
            <a:off x="4432378" y="54868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DC38493-746D-4DE2-8311-5322ABE948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5190" y="4084596"/>
            <a:ext cx="5464360" cy="2440748"/>
          </a:xfrm>
          <a:prstGeom prst="rect">
            <a:avLst/>
          </a:prstGeom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2B025C3-CABD-4E7D-839A-F1E3609E7231}"/>
              </a:ext>
            </a:extLst>
          </p:cNvPr>
          <p:cNvSpPr txBox="1"/>
          <p:nvPr/>
        </p:nvSpPr>
        <p:spPr>
          <a:xfrm>
            <a:off x="251520" y="386104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C83A5BD-F063-4D2A-8683-2154CE346A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80079" y="646424"/>
            <a:ext cx="4169528" cy="2931382"/>
          </a:xfrm>
          <a:prstGeom prst="rect">
            <a:avLst/>
          </a:prstGeom>
          <a:ln>
            <a:noFill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D143709-69A5-3DEA-6215-9375A4C08C21}"/>
              </a:ext>
            </a:extLst>
          </p:cNvPr>
          <p:cNvSpPr txBox="1"/>
          <p:nvPr/>
        </p:nvSpPr>
        <p:spPr>
          <a:xfrm>
            <a:off x="5868144" y="3645024"/>
            <a:ext cx="3024336" cy="3146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600"/>
              </a:spcAft>
            </a:pPr>
            <a:r>
              <a:rPr lang="en-GB" sz="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. Additional Western blots showing different CRISPR clones generated from each construct. (Refers to Figure 1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ecrosome protein levels in two BW5147 RIPK3 or MLKL KO CRISPR clones (#1 &amp; #2) generated by Horizon in comparison </a:t>
            </a:r>
            <a:r>
              <a:rPr lang="en-GB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</a:t>
            </a: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BW5147-parental cells, measured by Western blotting. Lysates were prepared after treatment with 1 µM tolinapant plus zVAD for 24 h. Clone #1 was selected in each case for use in experiment shown in Figure 1 and Figure S2. </a:t>
            </a: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arison Western blots of lysates from three KARPAS-299-RIPK3 clones (labelled low, intermediate, or high depending on RIPK3 expression level) treated for 0, 2 or 6 h with 1 µM tolinapant in the absence or presence of zVAD. The high RIPK3 clone was used for further investigation (Figure 1 and Figure S2). </a:t>
            </a: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arison protein levels from two EL4-C8KO clones (#1 &amp; #2) generated by Horizon in comparison to EL4-parental cell lysate after treatment with 1 µM tolinapant +/- 10 ng/mL TNF</a:t>
            </a:r>
            <a:r>
              <a:rPr lang="en-GB" sz="8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or 24 h. Clone#2 was selected for use in experiment in Figure 1 and Figure S2 as there was higher phospho-MLKL expression induced in this clone compared to Clone#1.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4094078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210</TotalTime>
  <Words>240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Astex Pharmaceuticals PowerPoint Template US_061113</vt:lpstr>
      <vt:lpstr>PowerPoint Presentation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2</cp:revision>
  <cp:lastPrinted>2020-03-10T12:57:33Z</cp:lastPrinted>
  <dcterms:created xsi:type="dcterms:W3CDTF">2018-10-12T15:56:46Z</dcterms:created>
  <dcterms:modified xsi:type="dcterms:W3CDTF">2024-02-13T11:03:39Z</dcterms:modified>
</cp:coreProperties>
</file>